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FB8F87-B9A8-416A-8ED2-1C8B718D63C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F502A7-99CF-432B-B64C-D6A3CF6D95C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C792F0-070A-4AA4-9CCE-D145015C0E4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22116B-BDB2-4418-83C5-5572127AE3C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7B1657-1362-4C79-982D-C37E92E6BA6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234A89-2915-48AD-8743-ED7C867437D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C6A455-3876-49A8-8C34-C3CAAC2E531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2FEDB4-3E1B-4805-9905-E8E2992EFDF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BC5C95-E6D0-4029-B4FC-12668622F12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3F3F9E-9450-4994-B1D9-65F2EEDFE17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C40D30-90E5-4CC4-B498-400B136077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88A1AD-18A2-4E88-927F-59A9B2A186D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nb-NO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nb-NO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60FDEBB-853A-4979-B230-18CDF0DC6F58}" type="slidenum">
              <a:rPr b="0" lang="nb-NO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" descr="NER_1.png"/>
          <p:cNvPicPr/>
          <p:nvPr/>
        </p:nvPicPr>
        <p:blipFill>
          <a:blip r:embed="rId1"/>
          <a:stretch/>
        </p:blipFill>
        <p:spPr>
          <a:xfrm>
            <a:off x="179280" y="71280"/>
            <a:ext cx="8569440" cy="5518440"/>
          </a:xfrm>
          <a:prstGeom prst="rect">
            <a:avLst/>
          </a:prstGeom>
          <a:ln w="0">
            <a:noFill/>
          </a:ln>
        </p:spPr>
      </p:pic>
      <p:sp>
        <p:nvSpPr>
          <p:cNvPr id="42" name="TextBox 2"/>
          <p:cNvSpPr/>
          <p:nvPr/>
        </p:nvSpPr>
        <p:spPr>
          <a:xfrm>
            <a:off x="250920" y="5732640"/>
            <a:ext cx="8497800" cy="1372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DDB1: damage-specific DNA binding protein 1, 127kDa, RPA1: replication protein A1, 70kDa, XPA: xeroderma pigmentosum, complementation group A, XPF: xeroderma pigmentosum, complementation group F,  alias for ERCC4: excision repair cross-complementing rodent repair deficiency, complementation group 4, POLD: polymerase (DNA directed), delta 1, catalytic subunit 125kDa, ERCC8: excision repair cross-complementing rodent repair deficiency, complementation group 8, XAB2: XPA binding protein 2, TFIIH complex: Includes ERCC2 (excision repair cross-complementing rodent repair deficiency, complementation group 2), ERCC3 (excision repair cross-complementing rodent repair deficiency, complementation group 3), GTF2H4: general transcription factor IIH, polypeptide 4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7-15T11:13:19Z</dcterms:created>
  <dc:creator>Siv Kjølsrud Bøhn</dc:creator>
  <dc:description/>
  <dc:language>en-US</dc:language>
  <cp:lastModifiedBy>Siv Kjølsrud Bøhn</cp:lastModifiedBy>
  <dcterms:modified xsi:type="dcterms:W3CDTF">2010-07-16T10:24:57Z</dcterms:modified>
  <cp:revision>2</cp:revision>
  <dc:subject/>
  <dc:title>Slide 1</dc:title>
</cp:coreProperties>
</file>